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70" d="100"/>
          <a:sy n="70" d="100"/>
        </p:scale>
        <p:origin x="-112" y="-28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370A7-F1F2-8A4E-87E7-7B7592277DA5}" type="datetimeFigureOut">
              <a:t>3/1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53ABDF-D8A5-1443-85A5-A8CC7C2F51E3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54617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370A7-F1F2-8A4E-87E7-7B7592277DA5}" type="datetimeFigureOut">
              <a:t>3/1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53ABDF-D8A5-1443-85A5-A8CC7C2F51E3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64207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370A7-F1F2-8A4E-87E7-7B7592277DA5}" type="datetimeFigureOut">
              <a:t>3/1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53ABDF-D8A5-1443-85A5-A8CC7C2F51E3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71174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370A7-F1F2-8A4E-87E7-7B7592277DA5}" type="datetimeFigureOut">
              <a:t>3/1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53ABDF-D8A5-1443-85A5-A8CC7C2F51E3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69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370A7-F1F2-8A4E-87E7-7B7592277DA5}" type="datetimeFigureOut">
              <a:t>3/1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53ABDF-D8A5-1443-85A5-A8CC7C2F51E3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99393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370A7-F1F2-8A4E-87E7-7B7592277DA5}" type="datetimeFigureOut">
              <a:t>3/10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53ABDF-D8A5-1443-85A5-A8CC7C2F51E3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4288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370A7-F1F2-8A4E-87E7-7B7592277DA5}" type="datetimeFigureOut">
              <a:t>3/10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53ABDF-D8A5-1443-85A5-A8CC7C2F51E3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20079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370A7-F1F2-8A4E-87E7-7B7592277DA5}" type="datetimeFigureOut">
              <a:t>3/10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53ABDF-D8A5-1443-85A5-A8CC7C2F51E3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46151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370A7-F1F2-8A4E-87E7-7B7592277DA5}" type="datetimeFigureOut">
              <a:t>3/10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53ABDF-D8A5-1443-85A5-A8CC7C2F51E3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32399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370A7-F1F2-8A4E-87E7-7B7592277DA5}" type="datetimeFigureOut">
              <a:t>3/10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53ABDF-D8A5-1443-85A5-A8CC7C2F51E3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73041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370A7-F1F2-8A4E-87E7-7B7592277DA5}" type="datetimeFigureOut">
              <a:t>3/10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53ABDF-D8A5-1443-85A5-A8CC7C2F51E3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23227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7370A7-F1F2-8A4E-87E7-7B7592277DA5}" type="datetimeFigureOut">
              <a:t>3/1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53ABDF-D8A5-1443-85A5-A8CC7C2F51E3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832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924726" y="676872"/>
            <a:ext cx="40881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/>
                <a:cs typeface="Arial"/>
              </a:rPr>
              <a:t>S7 Table </a:t>
            </a:r>
            <a:r>
              <a:rPr lang="en-US" sz="1400" b="1" dirty="0" smtClean="0">
                <a:latin typeface="Arial"/>
                <a:cs typeface="Arial"/>
              </a:rPr>
              <a:t>Data summary table for figure 4E </a:t>
            </a:r>
            <a:endParaRPr lang="en-US" sz="1400" b="1" dirty="0">
              <a:latin typeface="Arial"/>
              <a:cs typeface="Arial"/>
            </a:endParaRPr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39096035"/>
              </p:ext>
            </p:extLst>
          </p:nvPr>
        </p:nvGraphicFramePr>
        <p:xfrm>
          <a:off x="1011034" y="984649"/>
          <a:ext cx="7274511" cy="5231655"/>
        </p:xfrm>
        <a:graphic>
          <a:graphicData uri="http://schemas.openxmlformats.org/drawingml/2006/table">
            <a:tbl>
              <a:tblPr/>
              <a:tblGrid>
                <a:gridCol w="1672884"/>
                <a:gridCol w="646342"/>
                <a:gridCol w="925156"/>
                <a:gridCol w="570301"/>
                <a:gridCol w="494262"/>
                <a:gridCol w="443567"/>
                <a:gridCol w="481587"/>
                <a:gridCol w="494262"/>
                <a:gridCol w="481587"/>
                <a:gridCol w="1064563"/>
              </a:tblGrid>
              <a:tr h="1676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roup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ime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eriment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ND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NA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EL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NB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UD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LG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otal cells (n)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</a:tr>
              <a:tr h="167628">
                <a:tc rowSpan="11">
                  <a:txBody>
                    <a:bodyPr/>
                    <a:lstStyle/>
                    <a:p>
                      <a:pPr algn="ctr" fontAlgn="ctr"/>
                      <a:r>
                        <a:rPr lang="es-ES_tradnl" sz="12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dc12-6</a:t>
                      </a:r>
                      <a:r>
                        <a:rPr lang="es-ES_tradnl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(37</a:t>
                      </a:r>
                      <a:r>
                        <a:rPr lang="es-ES_tradnl" sz="12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  <a:r>
                        <a:rPr lang="es-ES_tradnl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)</a:t>
                      </a:r>
                    </a:p>
                  </a:txBody>
                  <a:tcPr marL="10885" marR="10885" marT="108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0</a:t>
                      </a:r>
                    </a:p>
                  </a:txBody>
                  <a:tcPr marL="10885" marR="10885" marT="108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1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5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4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0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76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2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6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7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2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76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3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2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9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76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9">
                  <a:txBody>
                    <a:bodyPr/>
                    <a:lstStyle/>
                    <a:p>
                      <a:pPr algn="ctr" fontAlgn="b"/>
                      <a:r>
                        <a:rPr lang="sk-SK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76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is-I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2</a:t>
                      </a:r>
                    </a:p>
                  </a:txBody>
                  <a:tcPr marL="10885" marR="10885" marT="108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1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4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6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2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4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76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2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4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7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7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76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3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9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2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8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8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6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54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76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9">
                  <a:txBody>
                    <a:bodyPr/>
                    <a:lstStyle/>
                    <a:p>
                      <a:pPr algn="ctr" fontAlgn="b"/>
                      <a:r>
                        <a:rPr lang="sk-SK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76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4</a:t>
                      </a:r>
                    </a:p>
                  </a:txBody>
                  <a:tcPr marL="10885" marR="10885" marT="108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1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7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5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68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76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2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3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0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81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76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3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6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3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62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76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roup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ime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eriment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ND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NA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EL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NB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UD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LG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otal cells (n)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</a:tr>
              <a:tr h="167628">
                <a:tc rowSpan="14">
                  <a:txBody>
                    <a:bodyPr/>
                    <a:lstStyle/>
                    <a:p>
                      <a:pPr algn="ctr" fontAlgn="ctr"/>
                      <a:r>
                        <a:rPr lang="it-IT" sz="12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dc12-6 cdh1∆</a:t>
                      </a:r>
                      <a:r>
                        <a:rPr lang="it-IT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(37</a:t>
                      </a:r>
                      <a:r>
                        <a:rPr lang="it-IT" sz="12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  <a:r>
                        <a:rPr lang="it-IT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)</a:t>
                      </a:r>
                    </a:p>
                  </a:txBody>
                  <a:tcPr marL="10885" marR="10885" marT="108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0</a:t>
                      </a:r>
                    </a:p>
                  </a:txBody>
                  <a:tcPr marL="10885" marR="10885" marT="108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1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1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5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0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5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76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2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6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1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6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3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76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3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2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7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7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9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76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4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7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5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6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2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76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9">
                  <a:txBody>
                    <a:bodyPr/>
                    <a:lstStyle/>
                    <a:p>
                      <a:pPr algn="ctr" fontAlgn="b"/>
                      <a:r>
                        <a:rPr lang="sk-SK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76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is-I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2</a:t>
                      </a:r>
                    </a:p>
                  </a:txBody>
                  <a:tcPr marL="10885" marR="10885" marT="108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1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8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7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9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65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76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2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3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1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5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76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3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4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6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4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4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76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4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2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6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8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2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76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9">
                  <a:txBody>
                    <a:bodyPr/>
                    <a:lstStyle/>
                    <a:p>
                      <a:pPr algn="ctr" fontAlgn="b"/>
                      <a:r>
                        <a:rPr lang="sk-SK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76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4</a:t>
                      </a:r>
                    </a:p>
                  </a:txBody>
                  <a:tcPr marL="10885" marR="10885" marT="108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1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7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6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6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7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7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76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2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5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8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8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76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3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0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4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6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51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76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4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9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4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0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6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4</a:t>
                      </a:r>
                    </a:p>
                  </a:txBody>
                  <a:tcPr marL="10885" marR="10885" marT="1088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429422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24</Words>
  <Application>Microsoft Macintosh PowerPoint</Application>
  <PresentationFormat>On-screen Show (4:3)</PresentationFormat>
  <Paragraphs>20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Case Western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n Tartakoff</dc:creator>
  <cp:lastModifiedBy>Alan Tartakoff</cp:lastModifiedBy>
  <cp:revision>2</cp:revision>
  <dcterms:created xsi:type="dcterms:W3CDTF">2017-03-10T17:55:56Z</dcterms:created>
  <dcterms:modified xsi:type="dcterms:W3CDTF">2017-03-10T17:58:11Z</dcterms:modified>
</cp:coreProperties>
</file>